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3959225" cy="540067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9F0D14-D194-418D-B825-9276A718F3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98360" y="216000"/>
            <a:ext cx="3564000" cy="900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98360" y="1260360"/>
            <a:ext cx="356400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98360" y="3122280"/>
            <a:ext cx="356400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12337D-B512-440B-B29E-62576AD327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98360" y="216000"/>
            <a:ext cx="3564000" cy="900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98360" y="1260360"/>
            <a:ext cx="173916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025000" y="1260360"/>
            <a:ext cx="173916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98360" y="3122280"/>
            <a:ext cx="173916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025000" y="3122280"/>
            <a:ext cx="173916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5A73CC-5B77-442E-81AC-0400974397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98360" y="216000"/>
            <a:ext cx="3564000" cy="900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98360" y="1260360"/>
            <a:ext cx="114732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403280" y="1260360"/>
            <a:ext cx="114732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608560" y="1260360"/>
            <a:ext cx="114732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98360" y="3122280"/>
            <a:ext cx="114732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403280" y="3122280"/>
            <a:ext cx="114732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608560" y="3122280"/>
            <a:ext cx="114732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77C6F9-2282-4DEF-AA5D-7F1C37B028E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98360" y="216000"/>
            <a:ext cx="3564000" cy="900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98360" y="1260360"/>
            <a:ext cx="3564000" cy="3564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76"/>
              </a:spcBef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7C7B8F-A791-4555-BB57-293F7CCE9B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98360" y="216000"/>
            <a:ext cx="3564000" cy="900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98360" y="1260360"/>
            <a:ext cx="3564000" cy="3564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50D89C-709F-4D62-B0AB-352DCC283B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98360" y="216000"/>
            <a:ext cx="3564000" cy="900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98360" y="1260360"/>
            <a:ext cx="1739160" cy="3564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025000" y="1260360"/>
            <a:ext cx="1739160" cy="3564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FE1E6E-7378-4C74-AC99-8D92F751FC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98360" y="216000"/>
            <a:ext cx="3564000" cy="900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25AA9B-34CA-4852-B10B-78136B264C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98360" y="216000"/>
            <a:ext cx="3564000" cy="4173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76"/>
              </a:spcBef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D83CF4-301B-4E45-9625-EDDCA1C319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98360" y="216000"/>
            <a:ext cx="3564000" cy="900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98360" y="1260360"/>
            <a:ext cx="173916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025000" y="1260360"/>
            <a:ext cx="1739160" cy="3564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98360" y="3122280"/>
            <a:ext cx="173916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07606E-B367-4955-8596-D349FEA572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98360" y="216000"/>
            <a:ext cx="3564000" cy="900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98360" y="1260360"/>
            <a:ext cx="1739160" cy="3564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025000" y="1260360"/>
            <a:ext cx="173916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025000" y="3122280"/>
            <a:ext cx="173916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070252-44A3-4D75-BC6F-D9C818B109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98360" y="216000"/>
            <a:ext cx="3564000" cy="900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98360" y="1260360"/>
            <a:ext cx="173916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025000" y="1260360"/>
            <a:ext cx="173916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98360" y="3122280"/>
            <a:ext cx="3564000" cy="169992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D9466D-517B-4511-8E6A-085483BA15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98360" y="216000"/>
            <a:ext cx="3564000" cy="900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ctr">
            <a:noAutofit/>
          </a:bodyPr>
          <a:p>
            <a:pPr indent="0" algn="ctr"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98360" y="1260360"/>
            <a:ext cx="3564000" cy="356400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t">
            <a:normAutofit/>
          </a:bodyPr>
          <a:p>
            <a:pPr marL="200160" indent="-200160">
              <a:spcBef>
                <a:spcPts val="476"/>
              </a:spcBef>
              <a:buClr>
                <a:srgbClr val="000000"/>
              </a:buClr>
              <a:buFont typeface="Arial"/>
              <a:buChar char="•"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1" marL="434880" indent="-168120">
              <a:spcBef>
                <a:spcPts val="476"/>
              </a:spcBef>
              <a:buClr>
                <a:srgbClr val="000000"/>
              </a:buClr>
              <a:buFont typeface="Arial"/>
              <a:buChar char="–"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2" marL="668160" indent="-133200">
              <a:spcBef>
                <a:spcPts val="476"/>
              </a:spcBef>
              <a:buClr>
                <a:srgbClr val="000000"/>
              </a:buClr>
              <a:buFont typeface="Arial"/>
              <a:buChar char="•"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3" marL="936720" indent="-135000">
              <a:spcBef>
                <a:spcPts val="476"/>
              </a:spcBef>
              <a:buClr>
                <a:srgbClr val="000000"/>
              </a:buClr>
              <a:buFont typeface="Arial"/>
              <a:buChar char="–"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4" marL="1203480" indent="-133560">
              <a:spcBef>
                <a:spcPts val="476"/>
              </a:spcBef>
              <a:buClr>
                <a:srgbClr val="000000"/>
              </a:buClr>
              <a:buFont typeface="Arial"/>
              <a:buChar char="»"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5" marL="1203480" indent="-133560">
              <a:spcBef>
                <a:spcPts val="476"/>
              </a:spcBef>
              <a:buClr>
                <a:srgbClr val="000000"/>
              </a:buClr>
              <a:buFont typeface="Arial"/>
              <a:buChar char="»"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6" marL="1203480" indent="-133560">
              <a:spcBef>
                <a:spcPts val="476"/>
              </a:spcBef>
              <a:buClr>
                <a:srgbClr val="000000"/>
              </a:buClr>
              <a:buFont typeface="Arial"/>
              <a:buChar char="»"/>
              <a:tabLst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98000" y="5005440"/>
            <a:ext cx="924120" cy="28728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ctr">
            <a:noAutofit/>
          </a:bodyPr>
          <a:lstStyle>
            <a:lvl1pPr indent="0"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r>
              <a:rPr b="0" lang="en-US" sz="7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352520" y="5005440"/>
            <a:ext cx="1255680" cy="28728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838600" y="5005440"/>
            <a:ext cx="923760" cy="287280"/>
          </a:xfrm>
          <a:prstGeom prst="rect">
            <a:avLst/>
          </a:prstGeom>
          <a:noFill/>
          <a:ln w="0">
            <a:noFill/>
          </a:ln>
        </p:spPr>
        <p:txBody>
          <a:bodyPr lIns="53640" rIns="53640" tIns="26640" bIns="26640" anchor="ctr">
            <a:noAutofit/>
          </a:bodyPr>
          <a:lstStyle>
            <a:lvl1pPr indent="0" algn="r"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534960"/>
                <a:tab algn="l" pos="1069920"/>
                <a:tab algn="l" pos="1604880"/>
                <a:tab algn="l" pos="2139840"/>
                <a:tab algn="l" pos="2674800"/>
                <a:tab algn="l" pos="3209760"/>
                <a:tab algn="l" pos="3745080"/>
                <a:tab algn="l" pos="4280040"/>
                <a:tab algn="l" pos="4815000"/>
                <a:tab algn="l" pos="5349960"/>
                <a:tab algn="l" pos="5884920"/>
                <a:tab algn="l" pos="6419880"/>
                <a:tab algn="l" pos="6954840"/>
                <a:tab algn="l" pos="7489800"/>
                <a:tab algn="l" pos="8024760"/>
                <a:tab algn="l" pos="8559720"/>
                <a:tab algn="l" pos="9094680"/>
                <a:tab algn="l" pos="9629640"/>
                <a:tab algn="l" pos="10164600"/>
                <a:tab algn="l" pos="10699920"/>
              </a:tabLst>
            </a:pPr>
            <a:fld id="{E39FD7C6-115A-46B8-B677-90DCB9401754}" type="slidenum">
              <a:rPr b="0" lang="en-US" sz="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7"/>
          <p:cNvSpPr/>
          <p:nvPr/>
        </p:nvSpPr>
        <p:spPr>
          <a:xfrm rot="16200000">
            <a:off x="-383760" y="1848960"/>
            <a:ext cx="1943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Calibri"/>
                <a:ea typeface="Arial"/>
              </a:rPr>
              <a:t>True positive rat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 Box 8"/>
          <p:cNvSpPr/>
          <p:nvPr/>
        </p:nvSpPr>
        <p:spPr>
          <a:xfrm>
            <a:off x="947880" y="3922560"/>
            <a:ext cx="1873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Arial"/>
              </a:rPr>
              <a:t>False positive rat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10" descr=""/>
          <p:cNvPicPr/>
          <p:nvPr/>
        </p:nvPicPr>
        <p:blipFill>
          <a:blip r:embed="rId1"/>
          <a:stretch/>
        </p:blipFill>
        <p:spPr>
          <a:xfrm>
            <a:off x="676440" y="38160"/>
            <a:ext cx="2095200" cy="395280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108000" y="4357800"/>
            <a:ext cx="381636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Supplementary Figure 1: 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Receiver-operating characteristic (ROC) curve analysis for miR-BART 17 copy numbers in plasma samples from 26 NPC patients (see Table 1) compared to 10 controls (see Table 2). 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Arial"/>
              </a:rPr>
              <a:t>From the ROC curve, the AUC (area under the curve) was calculated allowing determination of a cut-off value at 506 copies per mL with a sensitivity of 77% and a specificity of 90%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29T17:45:08Z</dcterms:created>
  <dc:creator>françois-régis</dc:creator>
  <dc:description/>
  <dc:language>en-US</dc:language>
  <cp:lastModifiedBy>Administrateur</cp:lastModifiedBy>
  <dcterms:modified xsi:type="dcterms:W3CDTF">2013-03-21T10:17:23Z</dcterms:modified>
  <cp:revision>3</cp:revision>
  <dc:subject/>
  <dc:title>Supplementary figure 1: Receiver-operating characteristic (ROC) curve analysis for miR-BART 17 copy numbers in plasma samples from 26 NPC patients (1-26) compared to controls (C1-10).</dc:title>
</cp:coreProperties>
</file>